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1" r:id="rId5"/>
    <p:sldId id="268" r:id="rId6"/>
    <p:sldId id="259" r:id="rId7"/>
    <p:sldId id="260" r:id="rId8"/>
    <p:sldId id="264" r:id="rId9"/>
    <p:sldId id="266" r:id="rId10"/>
    <p:sldId id="263" r:id="rId11"/>
    <p:sldId id="262" r:id="rId12"/>
    <p:sldId id="267" r:id="rId1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957" autoAdjust="0"/>
    <p:restoredTop sz="94660" autoAdjust="0"/>
  </p:normalViewPr>
  <p:slideViewPr>
    <p:cSldViewPr>
      <p:cViewPr>
        <p:scale>
          <a:sx n="90" d="100"/>
          <a:sy n="90" d="100"/>
        </p:scale>
        <p:origin x="-2286" y="-54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980728"/>
            <a:ext cx="7772400" cy="1470025"/>
          </a:xfrm>
        </p:spPr>
        <p:txBody>
          <a:bodyPr/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Biological replicate 1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899592" y="2924944"/>
            <a:ext cx="7488832" cy="4580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Marker: DL2000 (1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5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7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0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20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833966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1124744"/>
            <a:ext cx="7772400" cy="1470025"/>
          </a:xfrm>
        </p:spPr>
        <p:txBody>
          <a:bodyPr/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Biological replicate 2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899592" y="2924944"/>
            <a:ext cx="7488832" cy="4580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Marker: DL2000 (1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5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75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0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20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183625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4052481"/>
            <a:ext cx="8028000" cy="26168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832" y="836712"/>
            <a:ext cx="3965575" cy="21891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187624" y="3718983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FSS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189112" y="3349651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9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915816" y="3739935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ED-FBC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148064" y="3739935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SV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876256" y="3739935"/>
            <a:ext cx="1584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915816" y="3379895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2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149552" y="3379895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11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877744" y="3379895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7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384264" y="557972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347864" y="188640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6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54306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456" y="2636912"/>
            <a:ext cx="8208000" cy="21647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043608" y="2329135"/>
            <a:ext cx="2304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TE-MSV-MED-FAG-FBC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43608" y="1959803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5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51920" y="2329135"/>
            <a:ext cx="2448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SV-MED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851920" y="1959803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7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732240" y="2329135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FAG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732240" y="1959803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PBP2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100392" y="232913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TE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100392" y="1959803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OBP35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71320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945" y="846005"/>
            <a:ext cx="3550747" cy="24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503944" y="260648"/>
            <a:ext cx="1008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RPL10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03944" y="557972"/>
            <a:ext cx="3564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9556" y="4387319"/>
            <a:ext cx="8216900" cy="2219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891604" y="3717032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PBP1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28004" y="4086364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888444" y="4086364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860032" y="3717032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PBP2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2004" y="837613"/>
            <a:ext cx="4190285" cy="24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4968440" y="557972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932040" y="188640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5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13189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9211" y="3783285"/>
            <a:ext cx="7669213" cy="2886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881" y="836712"/>
            <a:ext cx="8156575" cy="2197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891604" y="188640"/>
            <a:ext cx="101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GO</a:t>
            </a: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BP1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28004" y="557972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004048" y="182809"/>
            <a:ext cx="101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GOBP2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040448" y="557972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80008" y="3213008"/>
            <a:ext cx="962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PBP3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080008" y="3501040"/>
            <a:ext cx="3564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860032" y="3212976"/>
            <a:ext cx="962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12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860032" y="3501008"/>
            <a:ext cx="3564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99367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3933056"/>
            <a:ext cx="8097837" cy="2663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362" y="709364"/>
            <a:ext cx="4057630" cy="24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910810" y="413956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74410" y="44624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8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042" y="709364"/>
            <a:ext cx="3772690" cy="24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5184464" y="413956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148064" y="44624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14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08000" y="3654316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71600" y="3284984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7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968440" y="3654316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932040" y="3284984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9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51259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6298" y="764704"/>
            <a:ext cx="8058150" cy="2266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4016077"/>
            <a:ext cx="8020050" cy="2581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35992" y="440696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99592" y="71364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10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040448" y="440696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004048" y="71364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35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040448" y="3726324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004048" y="3356992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6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80008" y="3726324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43608" y="3356992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11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77074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512" y="836712"/>
            <a:ext cx="4103952" cy="24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5040953" y="557972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004553" y="188640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16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4312369"/>
            <a:ext cx="8083550" cy="2212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872368" y="4041096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35968" y="3671764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17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968440" y="4041096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932040" y="3671764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18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333" y="836712"/>
            <a:ext cx="3890635" cy="24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863984" y="557972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27584" y="188640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15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11833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9719" y="4269507"/>
            <a:ext cx="8186737" cy="2255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1061" y="886147"/>
            <a:ext cx="8053387" cy="21828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008000" y="584712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71600" y="215380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19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040448" y="584712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004048" y="215380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0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08000" y="3942348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71600" y="3573016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1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040448" y="3942348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04048" y="3573016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2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6046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3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9913" y="910208"/>
            <a:ext cx="8004175" cy="2590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080008" y="629980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043608" y="260648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3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824424" y="629980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788024" y="260648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4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174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4327227"/>
            <a:ext cx="8080375" cy="2270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152016" y="4041096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115616" y="3671764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4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112456" y="4041096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076056" y="3671764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5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688742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4149080"/>
            <a:ext cx="8080375" cy="22304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0822" y="815279"/>
            <a:ext cx="4153911" cy="24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5062086" y="512704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025686" y="143372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8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80008" y="3870340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43608" y="3501008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36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040448" y="3870340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004048" y="3501008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37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815279"/>
            <a:ext cx="4059294" cy="24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890830" y="512704"/>
            <a:ext cx="3564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MAG-MTE-MSV-MED-FAG-FBC-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FOv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-FS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54430" y="143372"/>
            <a:ext cx="136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OBP27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6911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3</TotalTime>
  <Words>134</Words>
  <Application>Microsoft Office PowerPoint</Application>
  <PresentationFormat>全屏显示(4:3)</PresentationFormat>
  <Paragraphs>86</Paragraphs>
  <Slides>1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3" baseType="lpstr">
      <vt:lpstr>Office 主题</vt:lpstr>
      <vt:lpstr>Biological replicate 1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Biological replicate 2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ological replicate 1</dc:title>
  <dc:creator>dell</dc:creator>
  <cp:lastModifiedBy>dell</cp:lastModifiedBy>
  <cp:revision>11</cp:revision>
  <dcterms:created xsi:type="dcterms:W3CDTF">2022-12-05T04:08:11Z</dcterms:created>
  <dcterms:modified xsi:type="dcterms:W3CDTF">2022-12-06T05:41:15Z</dcterms:modified>
</cp:coreProperties>
</file>